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02" r:id="rId2"/>
    <p:sldId id="303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206"/>
    <p:restoredTop sz="94545"/>
  </p:normalViewPr>
  <p:slideViewPr>
    <p:cSldViewPr snapToGrid="0" snapToObjects="1">
      <p:cViewPr varScale="1">
        <p:scale>
          <a:sx n="74" d="100"/>
          <a:sy n="74" d="100"/>
        </p:scale>
        <p:origin x="5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49F27B-AF25-E44E-8774-00E88C80E945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E74411-B823-DA4A-AD81-9C0438342D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1970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E81DF6-0500-924E-B7EE-3CEEF98F0F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59328C6-7E44-C14A-9F2E-4B034A5ED6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DC5CDD-C86F-B445-BCCE-4D6079FE3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1B3B3D-F3FE-D548-940B-D773AA8E6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E101ED-1093-1B49-B6B0-12AE9B21B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952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61B316-4341-C94A-8D77-8BB23A07FF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BD147DD-1656-A04C-98EF-DE606B5D6A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148855-1912-044F-B610-F49F38C65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D752D3-386F-A041-BCE4-84902A49F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17D21A-468E-B141-A706-9E8271197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300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D2F189F-C26B-EF4F-9D5A-7B10308E5A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FD2DD0A-345B-9741-A7B2-170987A71A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5A3DCD-6DB7-C449-8354-FB37C2359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AC84C5-3390-7549-8CD7-2003F4A4F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8089FB-29A7-CB41-A6C5-90753BAB3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678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91EB95-C27F-E447-B8CE-629362F608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665975-D6E4-5443-AE4E-74E02CD780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87356D-7881-D147-9A3C-D9ECEF85C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CBEAE0A-4F68-D647-94DA-CE88C5187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4DC944-437E-B146-8B25-5AEBA7425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362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20C2F1-0D53-C748-94D1-37E951815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7EE92AB-940A-5240-B7E9-7927144B4A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917C9B-0A55-EB4E-8AD0-0AB4ECDF6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0280B0-C2B6-7745-9955-AEBDBC900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6E3895-66C8-C346-BFC5-49C43A2FE7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3382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47B82A-09F6-E140-80D4-E711D99085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CC2C7A6-29FC-9B4C-84A2-8A0ED18F87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8189CCC-6AD2-6D4D-BAFA-13EBA9EB5F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43FB11F-34EC-B649-A001-60CE4C408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0DC2180-5ADF-C147-B3D6-41A99BDB9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7C1E88B-73D2-7047-9C4E-E1FD14113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996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3B2859-9122-FE43-96F7-E39C949F29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19F45C9-7A4D-984E-815D-3A45A1E007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D79D6AE-186F-4E48-8913-1BDF0FBF59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5BCE710-A433-A747-8C67-CA613396FB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08BD4BE-9F2F-F144-B92F-4A7F173039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063B162-A0CD-4548-87C0-D12D9C0D9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DBF9418-6F85-064E-B327-62AA4D5E5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88360BE-3CF9-2445-A2C4-FEF41DCBC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15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1052CF-36E2-794A-8B54-8DB842FFE8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031EAA7-0E8F-224F-A656-A0B7A96B4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728F0AD-CC19-A64C-A50C-8A6DE9E6F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56F3598-8AF6-4143-874B-53B16741F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0862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6A62630-7771-B741-B1A1-83921C5AF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A13EB9B-82E0-0447-AF4F-92296A7CC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99F9BAF-B367-1948-9796-621F4910FA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573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9905ED-3E66-6C40-835C-DCD4824E12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65FC858-99FB-D749-844D-259F6AA349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833EED-285A-3941-9797-8C39C243E1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3CBCF60-8302-AD48-B0D6-4FE7BB80F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C3D51A2-0D26-2541-9627-5CA6A2BA7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B2B811-18D2-E94A-A937-6F9C1DA04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1012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255A81-BB6B-AF4D-8938-E6B1237C04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8957C62-116F-034E-B5A7-1C80F72C20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6781DB4-B280-C94C-B8B8-1189266C14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3B97483-DF38-A543-8740-6E1DCEBE1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2DB19F-6A7B-334D-BE44-CEE6C573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26CE5BA-9870-1149-9F51-1315F94B6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3422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B93D34A-41AC-3942-8476-75414B2A1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644030D-1EF5-6447-8A9A-411FC1F8A7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ED78B5-0E70-B94F-BB2B-FADE853FD7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151B3B-8379-9E42-9E2D-8A392F82EDB7}" type="datetimeFigureOut">
              <a:rPr kumimoji="1" lang="ja-JP" altLang="en-US" smtClean="0"/>
              <a:t>2019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5134C3-6E77-2944-9D92-7D7616AB76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E2070F-D6E3-6E48-86A3-F36DF40D6B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8DBAE-3F21-A542-BE69-906947BAE4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601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969020FB-4B71-774C-9E0D-1C0A8F2CD7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2812" y="4416794"/>
            <a:ext cx="3249129" cy="2441206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B01A5D50-3243-EC45-941D-B933855C78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2325" y="4264456"/>
            <a:ext cx="3451884" cy="2593544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D29B441B-F62F-0A43-8900-154CF4E20B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39003" y="962616"/>
            <a:ext cx="3837197" cy="2883046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7F64A0F-1A08-9145-89D6-5EC8A412E768}"/>
              </a:ext>
            </a:extLst>
          </p:cNvPr>
          <p:cNvSpPr txBox="1"/>
          <p:nvPr/>
        </p:nvSpPr>
        <p:spPr>
          <a:xfrm>
            <a:off x="4261244" y="804457"/>
            <a:ext cx="2978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. LOO (only Melancholic)</a:t>
            </a:r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B61FD22-AD31-244B-898C-09DD88DA985A}"/>
              </a:ext>
            </a:extLst>
          </p:cNvPr>
          <p:cNvSpPr txBox="1"/>
          <p:nvPr/>
        </p:nvSpPr>
        <p:spPr>
          <a:xfrm>
            <a:off x="601873" y="4015963"/>
            <a:ext cx="2549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. Independent cohort</a:t>
            </a:r>
            <a:endParaRPr kumimoji="1" lang="ja-JP" altLang="en-US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D77ACE72-F572-B04A-B52E-6102D3E434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8101" y="1015630"/>
            <a:ext cx="3833143" cy="2880000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42C8DD4-A481-7D40-B0FC-6B2D895C66A8}"/>
              </a:ext>
            </a:extLst>
          </p:cNvPr>
          <p:cNvSpPr txBox="1"/>
          <p:nvPr/>
        </p:nvSpPr>
        <p:spPr>
          <a:xfrm>
            <a:off x="601873" y="804457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. LOO</a:t>
            </a:r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D19FA1B-EAF0-1549-A37B-5D95821563EF}"/>
              </a:ext>
            </a:extLst>
          </p:cNvPr>
          <p:cNvSpPr txBox="1"/>
          <p:nvPr/>
        </p:nvSpPr>
        <p:spPr>
          <a:xfrm>
            <a:off x="4261244" y="4033334"/>
            <a:ext cx="25490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. Independent cohort</a:t>
            </a:r>
          </a:p>
          <a:p>
            <a:r>
              <a:rPr lang="en-US" altLang="ja-JP" dirty="0"/>
              <a:t>      (only Melancholic)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B7572AF-5913-A643-A8F0-F998BCC027E2}"/>
              </a:ext>
            </a:extLst>
          </p:cNvPr>
          <p:cNvSpPr txBox="1"/>
          <p:nvPr/>
        </p:nvSpPr>
        <p:spPr>
          <a:xfrm>
            <a:off x="601873" y="183020"/>
            <a:ext cx="78999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ure 1</a:t>
            </a:r>
          </a:p>
          <a:p>
            <a:r>
              <a:rPr lang="en-US" altLang="ja-JP" dirty="0"/>
              <a:t>The classification performance excluding global signal regression (GSR).</a:t>
            </a:r>
          </a:p>
        </p:txBody>
      </p:sp>
    </p:spTree>
    <p:extLst>
      <p:ext uri="{BB962C8B-B14F-4D97-AF65-F5344CB8AC3E}">
        <p14:creationId xmlns:p14="http://schemas.microsoft.com/office/powerpoint/2010/main" val="15652467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>
            <a:extLst>
              <a:ext uri="{FF2B5EF4-FFF2-40B4-BE49-F238E27FC236}">
                <a16:creationId xmlns:a16="http://schemas.microsoft.com/office/drawing/2014/main" id="{AE122AD9-3115-084B-A82A-33D278EDAD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350" y="2456924"/>
            <a:ext cx="5587589" cy="4198188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4CD543FE-2F59-2E41-8F93-CB475694AC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92150" y="2456924"/>
            <a:ext cx="5587589" cy="419818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851B28A-D910-D942-8D2E-9411662C9CD0}"/>
              </a:ext>
            </a:extLst>
          </p:cNvPr>
          <p:cNvSpPr txBox="1"/>
          <p:nvPr/>
        </p:nvSpPr>
        <p:spPr>
          <a:xfrm>
            <a:off x="349379" y="2456924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48E4F8E-7D43-4B4C-BA47-F6B69D16FC3E}"/>
              </a:ext>
            </a:extLst>
          </p:cNvPr>
          <p:cNvSpPr txBox="1"/>
          <p:nvPr/>
        </p:nvSpPr>
        <p:spPr>
          <a:xfrm>
            <a:off x="5543679" y="2456924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C8D1B0F-25D3-0845-AF86-0336C564F824}"/>
              </a:ext>
            </a:extLst>
          </p:cNvPr>
          <p:cNvSpPr txBox="1"/>
          <p:nvPr/>
        </p:nvSpPr>
        <p:spPr>
          <a:xfrm>
            <a:off x="516252" y="483078"/>
            <a:ext cx="102667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l Figure 2</a:t>
            </a:r>
          </a:p>
          <a:p>
            <a:r>
              <a:rPr lang="en-US" altLang="ja-JP" dirty="0"/>
              <a:t>The distribution</a:t>
            </a:r>
            <a:r>
              <a:rPr lang="ja-JP" altLang="ja-JP"/>
              <a:t> </a:t>
            </a:r>
            <a:r>
              <a:rPr lang="en-US" altLang="ja-JP" dirty="0"/>
              <a:t>of p-value of ANOVA for the interaction</a:t>
            </a:r>
            <a:r>
              <a:rPr lang="ja-JP" altLang="ja-JP"/>
              <a:t> </a:t>
            </a:r>
            <a:r>
              <a:rPr lang="en-US" altLang="ja-JP" dirty="0"/>
              <a:t>between site and other attributes such as age and sex</a:t>
            </a:r>
            <a:r>
              <a:rPr lang="ja-JP" altLang="ja-JP"/>
              <a:t> </a:t>
            </a:r>
            <a:r>
              <a:rPr lang="en-US" altLang="ja-JP" dirty="0"/>
              <a:t>for all FCs.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920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1</TotalTime>
  <Words>64</Words>
  <Application>Microsoft Macintosh PowerPoint</Application>
  <PresentationFormat>ワイド画面</PresentationFormat>
  <Paragraphs>1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Takashi</cp:lastModifiedBy>
  <cp:revision>92</cp:revision>
  <cp:lastPrinted>2019-07-19T02:08:47Z</cp:lastPrinted>
  <dcterms:created xsi:type="dcterms:W3CDTF">2018-06-22T06:33:54Z</dcterms:created>
  <dcterms:modified xsi:type="dcterms:W3CDTF">2019-10-09T04:26:15Z</dcterms:modified>
</cp:coreProperties>
</file>